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8" r:id="rId2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スタイルなし、表のグリッド線なし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073A0DAA-6AF3-43AB-8588-CEC1D06C72B9}" styleName="スタイル (中間)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6980" autoAdjust="0"/>
    <p:restoredTop sz="94660"/>
  </p:normalViewPr>
  <p:slideViewPr>
    <p:cSldViewPr snapToGrid="0" showGuides="1">
      <p:cViewPr>
        <p:scale>
          <a:sx n="87" d="100"/>
          <a:sy n="87" d="100"/>
        </p:scale>
        <p:origin x="280" y="188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CCFD2A4-5235-4583-A103-2D3D2147CC0A}" type="datetimeFigureOut">
              <a:rPr kumimoji="1" lang="ja-JP" altLang="en-US" smtClean="0"/>
              <a:t>2025/4/20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570B573-A9A0-4102-95CE-88665336458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6457063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570B573-A9A0-4102-95CE-88665336458A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1130261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95075793-3BE1-FBD8-92D5-6A9A0C427FA7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99038DD4-2F86-D417-AB9F-14782E8DFC0F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DFE3CA6F-DE9A-974F-3EF7-0B99225549B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14F6D8-C97C-4D8A-BD88-01051063AE85}" type="datetimeFigureOut">
              <a:rPr kumimoji="1" lang="ja-JP" altLang="en-US" smtClean="0"/>
              <a:t>2025/4/20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8AEA716D-1A83-B8D5-07F1-9E70E080CC0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D20483C8-6347-49DA-2738-748560E8DFF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B15CD4-581F-45A9-BF2B-5A28147F645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1291648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53DB48CE-F33E-0524-3F99-EFEC319A0AF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68F07723-7E4A-8B77-5094-87DDCE2294D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C22EB107-9BC7-4554-63CF-09017A6172A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14F6D8-C97C-4D8A-BD88-01051063AE85}" type="datetimeFigureOut">
              <a:rPr kumimoji="1" lang="ja-JP" altLang="en-US" smtClean="0"/>
              <a:t>2025/4/20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1961286C-E102-C095-6E65-0DC69D2B590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1A1161B3-2BFC-415A-45E5-C130252F221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B15CD4-581F-45A9-BF2B-5A28147F645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7087336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C39CF4FD-9F37-960C-9CBD-A14A4014A489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77085A51-B279-99D7-75A1-8A6DDE810D0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39C1F94F-46C7-87B3-65FD-5AC6D3216C7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14F6D8-C97C-4D8A-BD88-01051063AE85}" type="datetimeFigureOut">
              <a:rPr kumimoji="1" lang="ja-JP" altLang="en-US" smtClean="0"/>
              <a:t>2025/4/20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D4A44725-A4FF-9FD9-9705-2EB34DF9C9B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6DA4F5AC-D536-399B-C6B5-FCEACAE20D1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B15CD4-581F-45A9-BF2B-5A28147F645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7350545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D4447E9C-EBDB-FCF7-463A-8E9E4B16BEA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47F4A469-1185-0558-24BD-4D3890539E0A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7B851156-EBBA-DB65-5D8A-107388DBDAA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14F6D8-C97C-4D8A-BD88-01051063AE85}" type="datetimeFigureOut">
              <a:rPr kumimoji="1" lang="ja-JP" altLang="en-US" smtClean="0"/>
              <a:t>2025/4/20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10DACD48-222C-E5F5-6A1F-717313FC2B2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4A0CEDFB-89C9-B8EB-6956-093863F0ED9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B15CD4-581F-45A9-BF2B-5A28147F645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0812556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DA431E1C-76BF-5544-844C-0839D76346B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16674B49-B87E-E37F-CA78-6470965104E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848C2CA7-B12B-F37F-D920-376209D7CFE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14F6D8-C97C-4D8A-BD88-01051063AE85}" type="datetimeFigureOut">
              <a:rPr kumimoji="1" lang="ja-JP" altLang="en-US" smtClean="0"/>
              <a:t>2025/4/20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DDE81CFF-D3AE-D582-962E-EFCBFAD8236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2820F3A3-9BA6-C7ED-0765-9F114F3B98D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B15CD4-581F-45A9-BF2B-5A28147F645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878760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675D7CF4-E065-1634-919C-87718613C60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1CEA6AB0-CDC9-3860-7276-E0BE6FE6EFB1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C3522202-800C-CDD4-9AB7-650304FF32E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39C68983-61B5-D6C8-9899-A84FC681E5D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14F6D8-C97C-4D8A-BD88-01051063AE85}" type="datetimeFigureOut">
              <a:rPr kumimoji="1" lang="ja-JP" altLang="en-US" smtClean="0"/>
              <a:t>2025/4/20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74E0CF06-9334-129F-A897-ADD82C6953C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F659E3D5-BA74-FD4A-1D2B-96FD896A097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B15CD4-581F-45A9-BF2B-5A28147F645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8628029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C643104B-318B-66F1-77B6-DAF72629DFB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4842E0B7-0780-79A0-C282-FB5173A5615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34C60901-301C-D851-F0A9-B18D6FD97BD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DE91311E-08D4-C2EE-D05F-BBEEF91D5629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F056E979-8FC4-A6AB-7C4E-9EBF38E7EEDF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79B3E43D-A8D0-B925-0DFF-41950C2B220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14F6D8-C97C-4D8A-BD88-01051063AE85}" type="datetimeFigureOut">
              <a:rPr kumimoji="1" lang="ja-JP" altLang="en-US" smtClean="0"/>
              <a:t>2025/4/20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A3147CF2-E9BC-81E5-ED14-46FECF880BE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54ED6E69-9822-CBB3-BC74-B736B005FD2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B15CD4-581F-45A9-BF2B-5A28147F645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9136044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F7D5D7A4-9A28-E0B7-AA3D-BA8487B321A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0C9E4A16-C8BF-5D1C-B379-B80AA63768B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14F6D8-C97C-4D8A-BD88-01051063AE85}" type="datetimeFigureOut">
              <a:rPr kumimoji="1" lang="ja-JP" altLang="en-US" smtClean="0"/>
              <a:t>2025/4/20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F4666300-9631-49D8-521B-FB38E58D604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1DD8C262-707C-0EFA-665F-25CA65A4271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B15CD4-581F-45A9-BF2B-5A28147F645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0100830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68F7639A-C378-BD5B-69EC-541010DA4C4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14F6D8-C97C-4D8A-BD88-01051063AE85}" type="datetimeFigureOut">
              <a:rPr kumimoji="1" lang="ja-JP" altLang="en-US" smtClean="0"/>
              <a:t>2025/4/20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1EDBB3A2-8B68-FE1F-787E-80726F1933C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5257FADE-8384-CB86-1ED2-B81AF1F815B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B15CD4-581F-45A9-BF2B-5A28147F645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3560478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FA21CAA5-14B9-8D18-21C6-8711D8D7470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8FA8FF9D-5710-8334-1ACB-1281323CEA0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ADDD525A-9EF6-6957-4FE1-7E21BF3DB4B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AC4E8057-F464-4E21-A89A-BC67AFFD00F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14F6D8-C97C-4D8A-BD88-01051063AE85}" type="datetimeFigureOut">
              <a:rPr kumimoji="1" lang="ja-JP" altLang="en-US" smtClean="0"/>
              <a:t>2025/4/20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59A14FC8-0D50-374E-F238-E0605A7CB77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CBA01291-2428-D30D-763F-842E1DCBC0D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B15CD4-581F-45A9-BF2B-5A28147F645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9622661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F9E4F544-F126-F53A-152C-42797556E37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38B71A65-5C3F-D0E5-C11B-90F97F462076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D6F52834-B650-08A3-4C2E-2E4F1D191BD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A671F267-9C2B-80BA-E2E4-3F7CB0201A4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14F6D8-C97C-4D8A-BD88-01051063AE85}" type="datetimeFigureOut">
              <a:rPr kumimoji="1" lang="ja-JP" altLang="en-US" smtClean="0"/>
              <a:t>2025/4/20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5633BC4F-647F-3510-3161-76C55462208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A73262B8-7CA5-44A1-A1DF-7BD7F644CF7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B15CD4-581F-45A9-BF2B-5A28147F645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3595534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E6631BF4-7E83-4025-2DCF-09A232D2C60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FC70CEDD-8557-567F-FE61-73220680129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C9D479CE-EF39-33A7-1C00-9EC9B0B0B484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714F6D8-C97C-4D8A-BD88-01051063AE85}" type="datetimeFigureOut">
              <a:rPr kumimoji="1" lang="ja-JP" altLang="en-US" smtClean="0"/>
              <a:t>2025/4/20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F0D1799D-F9CA-78C9-FC2A-EF1E2AC16830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16153E49-A070-38F9-7A4A-9B41B8B8DFD9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CB15CD4-581F-45A9-BF2B-5A28147F645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81991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表 1">
            <a:extLst>
              <a:ext uri="{FF2B5EF4-FFF2-40B4-BE49-F238E27FC236}">
                <a16:creationId xmlns:a16="http://schemas.microsoft.com/office/drawing/2014/main" id="{883D2C2D-4BB8-6246-0090-63B43598A5B4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017440738"/>
              </p:ext>
            </p:extLst>
          </p:nvPr>
        </p:nvGraphicFramePr>
        <p:xfrm>
          <a:off x="141315" y="141311"/>
          <a:ext cx="11822085" cy="6605840"/>
        </p:xfrm>
        <a:graphic>
          <a:graphicData uri="http://schemas.openxmlformats.org/drawingml/2006/table">
            <a:tbl>
              <a:tblPr>
                <a:tableStyleId>{2D5ABB26-0587-4C30-8999-92F81FD0307C}</a:tableStyleId>
              </a:tblPr>
              <a:tblGrid>
                <a:gridCol w="433253">
                  <a:extLst>
                    <a:ext uri="{9D8B030D-6E8A-4147-A177-3AD203B41FA5}">
                      <a16:colId xmlns:a16="http://schemas.microsoft.com/office/drawing/2014/main" val="1776796759"/>
                    </a:ext>
                  </a:extLst>
                </a:gridCol>
                <a:gridCol w="1682631">
                  <a:extLst>
                    <a:ext uri="{9D8B030D-6E8A-4147-A177-3AD203B41FA5}">
                      <a16:colId xmlns:a16="http://schemas.microsoft.com/office/drawing/2014/main" val="4286875546"/>
                    </a:ext>
                  </a:extLst>
                </a:gridCol>
                <a:gridCol w="698576">
                  <a:extLst>
                    <a:ext uri="{9D8B030D-6E8A-4147-A177-3AD203B41FA5}">
                      <a16:colId xmlns:a16="http://schemas.microsoft.com/office/drawing/2014/main" val="3048813443"/>
                    </a:ext>
                  </a:extLst>
                </a:gridCol>
                <a:gridCol w="698576">
                  <a:extLst>
                    <a:ext uri="{9D8B030D-6E8A-4147-A177-3AD203B41FA5}">
                      <a16:colId xmlns:a16="http://schemas.microsoft.com/office/drawing/2014/main" val="1550606924"/>
                    </a:ext>
                  </a:extLst>
                </a:gridCol>
                <a:gridCol w="1222514">
                  <a:extLst>
                    <a:ext uri="{9D8B030D-6E8A-4147-A177-3AD203B41FA5}">
                      <a16:colId xmlns:a16="http://schemas.microsoft.com/office/drawing/2014/main" val="2824204553"/>
                    </a:ext>
                  </a:extLst>
                </a:gridCol>
                <a:gridCol w="1141906">
                  <a:extLst>
                    <a:ext uri="{9D8B030D-6E8A-4147-A177-3AD203B41FA5}">
                      <a16:colId xmlns:a16="http://schemas.microsoft.com/office/drawing/2014/main" val="2120099835"/>
                    </a:ext>
                  </a:extLst>
                </a:gridCol>
                <a:gridCol w="1319910">
                  <a:extLst>
                    <a:ext uri="{9D8B030D-6E8A-4147-A177-3AD203B41FA5}">
                      <a16:colId xmlns:a16="http://schemas.microsoft.com/office/drawing/2014/main" val="2805334992"/>
                    </a:ext>
                  </a:extLst>
                </a:gridCol>
                <a:gridCol w="2246869">
                  <a:extLst>
                    <a:ext uri="{9D8B030D-6E8A-4147-A177-3AD203B41FA5}">
                      <a16:colId xmlns:a16="http://schemas.microsoft.com/office/drawing/2014/main" val="2611649219"/>
                    </a:ext>
                  </a:extLst>
                </a:gridCol>
                <a:gridCol w="2377850">
                  <a:extLst>
                    <a:ext uri="{9D8B030D-6E8A-4147-A177-3AD203B41FA5}">
                      <a16:colId xmlns:a16="http://schemas.microsoft.com/office/drawing/2014/main" val="1990178512"/>
                    </a:ext>
                  </a:extLst>
                </a:gridCol>
              </a:tblGrid>
              <a:tr h="304874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 dirty="0">
                          <a:effectLst/>
                        </a:rPr>
                        <a:t>No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373" marR="4373" marT="4373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</a:rPr>
                        <a:t>Author (Year)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373" marR="4373" marT="4373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</a:rPr>
                        <a:t>Age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373" marR="4373" marT="4373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</a:rPr>
                        <a:t>Sex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373" marR="4373" marT="4373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</a:rPr>
                        <a:t>Valvular disease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373" marR="4373" marT="4373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</a:rPr>
                        <a:t>BAV or TAV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373" marR="4373" marT="4373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</a:rPr>
                        <a:t>Surgery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373" marR="4373" marT="4373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</a:rPr>
                        <a:t>Additional procedures during surgery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373" marR="4373" marT="4373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 dirty="0">
                          <a:effectLst/>
                        </a:rPr>
                        <a:t>Outcome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373" marR="4373" marT="4373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20305166"/>
                  </a:ext>
                </a:extLst>
              </a:tr>
              <a:tr h="150688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900" u="none" strike="noStrike">
                          <a:effectLst/>
                        </a:rPr>
                        <a:t>1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373" marR="4373" marT="4373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</a:rPr>
                        <a:t>Roberts et al (1969)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373" marR="4373" marT="4373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900" u="none" strike="noStrike">
                          <a:effectLst/>
                        </a:rPr>
                        <a:t>45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373" marR="4373" marT="4373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</a:rPr>
                        <a:t>Male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373" marR="4373" marT="4373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</a:rPr>
                        <a:t>MR/ AR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373" marR="4373" marT="4373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</a:rPr>
                        <a:t>Not available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373" marR="4373" marT="4373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</a:rPr>
                        <a:t>AVR and MVR 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373" marR="4373" marT="4373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</a:rPr>
                        <a:t>Not in particular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373" marR="4373" marT="4373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 dirty="0">
                          <a:effectLst/>
                        </a:rPr>
                        <a:t>Operative death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373" marR="4373" marT="4373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2772184234"/>
                  </a:ext>
                </a:extLst>
              </a:tr>
              <a:tr h="150688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900" u="none" strike="noStrike">
                          <a:effectLst/>
                        </a:rPr>
                        <a:t>2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373" marR="4373" marT="437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</a:rPr>
                        <a:t>same as above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373" marR="4373" marT="437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900" u="none" strike="noStrike">
                          <a:effectLst/>
                        </a:rPr>
                        <a:t>53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373" marR="4373" marT="437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</a:rPr>
                        <a:t>Female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373" marR="4373" marT="437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</a:rPr>
                        <a:t>MS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373" marR="4373" marT="437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</a:rPr>
                        <a:t>Not available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373" marR="4373" marT="437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</a:rPr>
                        <a:t>MVR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373" marR="4373" marT="437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</a:rPr>
                        <a:t>Not in particular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373" marR="4373" marT="437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 dirty="0">
                          <a:effectLst/>
                        </a:rPr>
                        <a:t>Sudden death 5 years after surgery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373" marR="4373" marT="4373" marB="0" anchor="ctr"/>
                </a:tc>
                <a:extLst>
                  <a:ext uri="{0D108BD9-81ED-4DB2-BD59-A6C34878D82A}">
                    <a16:rowId xmlns:a16="http://schemas.microsoft.com/office/drawing/2014/main" val="3656609"/>
                  </a:ext>
                </a:extLst>
              </a:tr>
              <a:tr h="150688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900" u="none" strike="noStrike">
                          <a:effectLst/>
                        </a:rPr>
                        <a:t>3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373" marR="4373" marT="437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</a:rPr>
                        <a:t>Veinot et al.(1998)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373" marR="4373" marT="437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900" u="none" strike="noStrike">
                          <a:effectLst/>
                        </a:rPr>
                        <a:t>29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373" marR="4373" marT="437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</a:rPr>
                        <a:t>Male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373" marR="4373" marT="437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</a:rPr>
                        <a:t>AR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373" marR="4373" marT="437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</a:rPr>
                        <a:t>BAV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373" marR="4373" marT="437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</a:rPr>
                        <a:t>AVR 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373" marR="4373" marT="437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</a:rPr>
                        <a:t>Not in particular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373" marR="4373" marT="437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 dirty="0">
                          <a:effectLst/>
                        </a:rPr>
                        <a:t>Sudden death 6 years after surgery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373" marR="4373" marT="4373" marB="0" anchor="ctr"/>
                </a:tc>
                <a:extLst>
                  <a:ext uri="{0D108BD9-81ED-4DB2-BD59-A6C34878D82A}">
                    <a16:rowId xmlns:a16="http://schemas.microsoft.com/office/drawing/2014/main" val="2701565672"/>
                  </a:ext>
                </a:extLst>
              </a:tr>
              <a:tr h="150688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900" u="none" strike="noStrike">
                          <a:effectLst/>
                        </a:rPr>
                        <a:t>4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373" marR="4373" marT="437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</a:rPr>
                        <a:t>Flores et al. (2001)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373" marR="4373" marT="437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900" u="none" strike="noStrike">
                          <a:effectLst/>
                        </a:rPr>
                        <a:t>78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373" marR="4373" marT="437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</a:rPr>
                        <a:t>Female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373" marR="4373" marT="437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</a:rPr>
                        <a:t>AS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373" marR="4373" marT="437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</a:rPr>
                        <a:t>TAV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373" marR="4373" marT="437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</a:rPr>
                        <a:t>AVR 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373" marR="4373" marT="437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</a:rPr>
                        <a:t>D&amp;R of the ALCX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373" marR="4373" marT="437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 dirty="0">
                          <a:effectLst/>
                        </a:rPr>
                        <a:t>Uneventful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373" marR="4373" marT="4373" marB="0" anchor="ctr"/>
                </a:tc>
                <a:extLst>
                  <a:ext uri="{0D108BD9-81ED-4DB2-BD59-A6C34878D82A}">
                    <a16:rowId xmlns:a16="http://schemas.microsoft.com/office/drawing/2014/main" val="3782464443"/>
                  </a:ext>
                </a:extLst>
              </a:tr>
              <a:tr h="296721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900" u="none" strike="noStrike">
                          <a:effectLst/>
                        </a:rPr>
                        <a:t>5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373" marR="4373" marT="437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</a:rPr>
                        <a:t>Castillo et al. (2009)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373" marR="4373" marT="437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900" u="none" strike="noStrike">
                          <a:effectLst/>
                        </a:rPr>
                        <a:t>59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373" marR="4373" marT="437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</a:rPr>
                        <a:t>Male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373" marR="4373" marT="437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</a:rPr>
                        <a:t>IE/AR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373" marR="4373" marT="437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</a:rPr>
                        <a:t>BAV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373" marR="4373" marT="437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</a:rPr>
                        <a:t>AVR 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373" marR="4373" marT="437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</a:rPr>
                        <a:t>D&amp;R of the ALCX</a:t>
                      </a:r>
                      <a:br>
                        <a:rPr lang="en-US" sz="900" u="none" strike="noStrike">
                          <a:effectLst/>
                        </a:rPr>
                      </a:br>
                      <a:r>
                        <a:rPr lang="en-US" sz="900" u="none" strike="noStrike">
                          <a:effectLst/>
                        </a:rPr>
                        <a:t>Selection of undersized PV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373" marR="4373" marT="437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</a:rPr>
                        <a:t>Uneventful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373" marR="4373" marT="4373" marB="0" anchor="ctr"/>
                </a:tc>
                <a:extLst>
                  <a:ext uri="{0D108BD9-81ED-4DB2-BD59-A6C34878D82A}">
                    <a16:rowId xmlns:a16="http://schemas.microsoft.com/office/drawing/2014/main" val="3351885649"/>
                  </a:ext>
                </a:extLst>
              </a:tr>
              <a:tr h="296721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900" u="none" strike="noStrike">
                          <a:effectLst/>
                        </a:rPr>
                        <a:t>6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373" marR="4373" marT="437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</a:rPr>
                        <a:t>Vaishnava et al. (2011)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373" marR="4373" marT="437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900" u="none" strike="noStrike">
                          <a:effectLst/>
                        </a:rPr>
                        <a:t>52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373" marR="4373" marT="437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</a:rPr>
                        <a:t>Male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373" marR="4373" marT="437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</a:rPr>
                        <a:t>ASR, MS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373" marR="4373" marT="437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</a:rPr>
                        <a:t>Not available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373" marR="4373" marT="437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</a:rPr>
                        <a:t>AVR and MVR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373" marR="4373" marT="437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</a:rPr>
                        <a:t>Selection of undersized PV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373" marR="4373" marT="437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 dirty="0">
                          <a:effectLst/>
                        </a:rPr>
                        <a:t>CABG and D&amp;R of the ALCX</a:t>
                      </a:r>
                      <a:br>
                        <a:rPr lang="en-US" sz="900" u="none" strike="noStrike" dirty="0">
                          <a:effectLst/>
                        </a:rPr>
                      </a:br>
                      <a:r>
                        <a:rPr lang="en-US" sz="900" u="none" strike="noStrike" dirty="0">
                          <a:effectLst/>
                        </a:rPr>
                        <a:t> for occluded ALCX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373" marR="4373" marT="4373" marB="0" anchor="ctr"/>
                </a:tc>
                <a:extLst>
                  <a:ext uri="{0D108BD9-81ED-4DB2-BD59-A6C34878D82A}">
                    <a16:rowId xmlns:a16="http://schemas.microsoft.com/office/drawing/2014/main" val="1039731549"/>
                  </a:ext>
                </a:extLst>
              </a:tr>
              <a:tr h="150688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900" u="none" strike="noStrike">
                          <a:effectLst/>
                        </a:rPr>
                        <a:t>7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373" marR="4373" marT="437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</a:rPr>
                        <a:t>Mennuni et al. (2011)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373" marR="4373" marT="437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900" u="none" strike="noStrike">
                          <a:effectLst/>
                        </a:rPr>
                        <a:t>84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373" marR="4373" marT="437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</a:rPr>
                        <a:t>Male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373" marR="4373" marT="437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</a:rPr>
                        <a:t>AS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373" marR="4373" marT="437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</a:rPr>
                        <a:t>Not available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373" marR="4373" marT="437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</a:rPr>
                        <a:t>TAVR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373" marR="4373" marT="437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</a:rPr>
                        <a:t>Not in particular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373" marR="4373" marT="437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</a:rPr>
                        <a:t>Uneventful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373" marR="4373" marT="4373" marB="0" anchor="ctr"/>
                </a:tc>
                <a:extLst>
                  <a:ext uri="{0D108BD9-81ED-4DB2-BD59-A6C34878D82A}">
                    <a16:rowId xmlns:a16="http://schemas.microsoft.com/office/drawing/2014/main" val="3357626106"/>
                  </a:ext>
                </a:extLst>
              </a:tr>
              <a:tr h="150688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900" u="none" strike="noStrike">
                          <a:effectLst/>
                        </a:rPr>
                        <a:t>8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373" marR="4373" marT="437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</a:rPr>
                        <a:t>Yokoyama et al. (2012)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373" marR="4373" marT="437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900" u="none" strike="noStrike">
                          <a:effectLst/>
                        </a:rPr>
                        <a:t>77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373" marR="4373" marT="437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</a:rPr>
                        <a:t>Female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373" marR="4373" marT="437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</a:rPr>
                        <a:t>AS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373" marR="4373" marT="437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</a:rPr>
                        <a:t>TAV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373" marR="4373" marT="437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</a:rPr>
                        <a:t>AVR 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373" marR="4373" marT="437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</a:rPr>
                        <a:t>Selection of undersized PV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373" marR="4373" marT="437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 dirty="0">
                          <a:effectLst/>
                        </a:rPr>
                        <a:t>Uneventful 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373" marR="4373" marT="4373" marB="0" anchor="ctr"/>
                </a:tc>
                <a:extLst>
                  <a:ext uri="{0D108BD9-81ED-4DB2-BD59-A6C34878D82A}">
                    <a16:rowId xmlns:a16="http://schemas.microsoft.com/office/drawing/2014/main" val="1024705228"/>
                  </a:ext>
                </a:extLst>
              </a:tr>
              <a:tr h="150688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900" u="none" strike="noStrike">
                          <a:effectLst/>
                        </a:rPr>
                        <a:t>9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373" marR="4373" marT="437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</a:rPr>
                        <a:t>Acosta-Vélez et al. (2014 )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373" marR="4373" marT="437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900" u="none" strike="noStrike">
                          <a:effectLst/>
                        </a:rPr>
                        <a:t>86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373" marR="4373" marT="437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</a:rPr>
                        <a:t>Female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373" marR="4373" marT="437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</a:rPr>
                        <a:t>AS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373" marR="4373" marT="437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</a:rPr>
                        <a:t>Not available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373" marR="4373" marT="437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</a:rPr>
                        <a:t>TAVR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373" marR="4373" marT="437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</a:rPr>
                        <a:t>CI for occluding the ALCX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373" marR="4373" marT="437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</a:rPr>
                        <a:t>Uneventful 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373" marR="4373" marT="4373" marB="0" anchor="ctr"/>
                </a:tc>
                <a:extLst>
                  <a:ext uri="{0D108BD9-81ED-4DB2-BD59-A6C34878D82A}">
                    <a16:rowId xmlns:a16="http://schemas.microsoft.com/office/drawing/2014/main" val="47947317"/>
                  </a:ext>
                </a:extLst>
              </a:tr>
              <a:tr h="150688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900" u="none" strike="noStrike">
                          <a:effectLst/>
                        </a:rPr>
                        <a:t>10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373" marR="4373" marT="437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</a:rPr>
                        <a:t>Liebrich et al. (2015)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373" marR="4373" marT="437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900" u="none" strike="noStrike">
                          <a:effectLst/>
                        </a:rPr>
                        <a:t>55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373" marR="4373" marT="437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</a:rPr>
                        <a:t>Male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373" marR="4373" marT="437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</a:rPr>
                        <a:t>AR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373" marR="4373" marT="437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</a:rPr>
                        <a:t>BAV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373" marR="4373" marT="437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</a:rPr>
                        <a:t>AVP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373" marR="4373" marT="437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</a:rPr>
                        <a:t>D&amp;R of the ALCX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373" marR="4373" marT="437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 dirty="0">
                          <a:effectLst/>
                        </a:rPr>
                        <a:t>Uneventful 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373" marR="4373" marT="4373" marB="0" anchor="ctr"/>
                </a:tc>
                <a:extLst>
                  <a:ext uri="{0D108BD9-81ED-4DB2-BD59-A6C34878D82A}">
                    <a16:rowId xmlns:a16="http://schemas.microsoft.com/office/drawing/2014/main" val="2927047264"/>
                  </a:ext>
                </a:extLst>
              </a:tr>
              <a:tr h="150688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900" u="none" strike="noStrike">
                          <a:effectLst/>
                        </a:rPr>
                        <a:t>11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373" marR="4373" marT="437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</a:rPr>
                        <a:t>same as above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373" marR="4373" marT="437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900" u="none" strike="noStrike">
                          <a:effectLst/>
                        </a:rPr>
                        <a:t>47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373" marR="4373" marT="437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</a:rPr>
                        <a:t>Male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373" marR="4373" marT="437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</a:rPr>
                        <a:t>AR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373" marR="4373" marT="437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</a:rPr>
                        <a:t>BAV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373" marR="4373" marT="437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</a:rPr>
                        <a:t>Remodeling method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373" marR="4373" marT="437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</a:rPr>
                        <a:t>D&amp;R of the ALCX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373" marR="4373" marT="437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</a:rPr>
                        <a:t>Uneventful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373" marR="4373" marT="4373" marB="0" anchor="ctr"/>
                </a:tc>
                <a:extLst>
                  <a:ext uri="{0D108BD9-81ED-4DB2-BD59-A6C34878D82A}">
                    <a16:rowId xmlns:a16="http://schemas.microsoft.com/office/drawing/2014/main" val="13823785"/>
                  </a:ext>
                </a:extLst>
              </a:tr>
              <a:tr h="150688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900" u="none" strike="noStrike">
                          <a:effectLst/>
                        </a:rPr>
                        <a:t>12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373" marR="4373" marT="437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</a:rPr>
                        <a:t>same as above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373" marR="4373" marT="437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900" u="none" strike="noStrike">
                          <a:effectLst/>
                        </a:rPr>
                        <a:t>81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373" marR="4373" marT="437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</a:rPr>
                        <a:t>Female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373" marR="4373" marT="437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</a:rPr>
                        <a:t>AS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373" marR="4373" marT="437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</a:rPr>
                        <a:t>BAV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373" marR="4373" marT="437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</a:rPr>
                        <a:t>AVR 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373" marR="4373" marT="437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</a:rPr>
                        <a:t>D&amp;R of the ALCX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373" marR="4373" marT="437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 dirty="0">
                          <a:effectLst/>
                        </a:rPr>
                        <a:t>Uneventful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373" marR="4373" marT="4373" marB="0" anchor="ctr"/>
                </a:tc>
                <a:extLst>
                  <a:ext uri="{0D108BD9-81ED-4DB2-BD59-A6C34878D82A}">
                    <a16:rowId xmlns:a16="http://schemas.microsoft.com/office/drawing/2014/main" val="2974872793"/>
                  </a:ext>
                </a:extLst>
              </a:tr>
              <a:tr h="150688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900" u="none" strike="noStrike">
                          <a:effectLst/>
                        </a:rPr>
                        <a:t>13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373" marR="4373" marT="437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</a:rPr>
                        <a:t>same as above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373" marR="4373" marT="437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900" u="none" strike="noStrike">
                          <a:effectLst/>
                        </a:rPr>
                        <a:t>67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373" marR="4373" marT="437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</a:rPr>
                        <a:t>Female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373" marR="4373" marT="437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</a:rPr>
                        <a:t>AS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373" marR="4373" marT="437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</a:rPr>
                        <a:t>BAV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373" marR="4373" marT="437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</a:rPr>
                        <a:t>AVR 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373" marR="4373" marT="437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</a:rPr>
                        <a:t>D&amp;R of the ALCX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373" marR="4373" marT="437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</a:rPr>
                        <a:t>Uneventful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373" marR="4373" marT="4373" marB="0" anchor="ctr"/>
                </a:tc>
                <a:extLst>
                  <a:ext uri="{0D108BD9-81ED-4DB2-BD59-A6C34878D82A}">
                    <a16:rowId xmlns:a16="http://schemas.microsoft.com/office/drawing/2014/main" val="186599929"/>
                  </a:ext>
                </a:extLst>
              </a:tr>
              <a:tr h="150688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900" u="none" strike="noStrike">
                          <a:effectLst/>
                        </a:rPr>
                        <a:t>14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373" marR="4373" marT="437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</a:rPr>
                        <a:t>same as above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373" marR="4373" marT="437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900" u="none" strike="noStrike">
                          <a:effectLst/>
                        </a:rPr>
                        <a:t>64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373" marR="4373" marT="437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</a:rPr>
                        <a:t>Male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373" marR="4373" marT="437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</a:rPr>
                        <a:t>AS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373" marR="4373" marT="437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</a:rPr>
                        <a:t>BAV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373" marR="4373" marT="437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</a:rPr>
                        <a:t>AVR 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373" marR="4373" marT="437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</a:rPr>
                        <a:t>D&amp;R of the ALCX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373" marR="4373" marT="437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 dirty="0">
                          <a:effectLst/>
                        </a:rPr>
                        <a:t>Uneventful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373" marR="4373" marT="4373" marB="0" anchor="ctr"/>
                </a:tc>
                <a:extLst>
                  <a:ext uri="{0D108BD9-81ED-4DB2-BD59-A6C34878D82A}">
                    <a16:rowId xmlns:a16="http://schemas.microsoft.com/office/drawing/2014/main" val="2521419918"/>
                  </a:ext>
                </a:extLst>
              </a:tr>
              <a:tr h="150688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900" u="none" strike="noStrike">
                          <a:effectLst/>
                        </a:rPr>
                        <a:t>15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373" marR="4373" marT="437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</a:rPr>
                        <a:t>same as above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373" marR="4373" marT="437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900" u="none" strike="noStrike">
                          <a:effectLst/>
                        </a:rPr>
                        <a:t>58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373" marR="4373" marT="437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</a:rPr>
                        <a:t>Male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373" marR="4373" marT="437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</a:rPr>
                        <a:t>AS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373" marR="4373" marT="437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</a:rPr>
                        <a:t>BAV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373" marR="4373" marT="437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</a:rPr>
                        <a:t>AVR 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373" marR="4373" marT="437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</a:rPr>
                        <a:t>D&amp;R of the ALCX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373" marR="4373" marT="437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 dirty="0">
                          <a:effectLst/>
                        </a:rPr>
                        <a:t>Uneventful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373" marR="4373" marT="4373" marB="0" anchor="ctr"/>
                </a:tc>
                <a:extLst>
                  <a:ext uri="{0D108BD9-81ED-4DB2-BD59-A6C34878D82A}">
                    <a16:rowId xmlns:a16="http://schemas.microsoft.com/office/drawing/2014/main" val="3010017989"/>
                  </a:ext>
                </a:extLst>
              </a:tr>
              <a:tr h="150688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900" u="none" strike="noStrike">
                          <a:effectLst/>
                        </a:rPr>
                        <a:t>16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373" marR="4373" marT="437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</a:rPr>
                        <a:t>Harky et al. (2017)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373" marR="4373" marT="437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900" u="none" strike="noStrike">
                          <a:effectLst/>
                        </a:rPr>
                        <a:t>52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373" marR="4373" marT="437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</a:rPr>
                        <a:t>Male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373" marR="4373" marT="437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</a:rPr>
                        <a:t>AS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373" marR="4373" marT="437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</a:rPr>
                        <a:t>BAV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373" marR="4373" marT="437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</a:rPr>
                        <a:t>AVR 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373" marR="4373" marT="437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</a:rPr>
                        <a:t>Not in particular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373" marR="4373" marT="437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</a:rPr>
                        <a:t>Uneventful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373" marR="4373" marT="4373" marB="0" anchor="ctr"/>
                </a:tc>
                <a:extLst>
                  <a:ext uri="{0D108BD9-81ED-4DB2-BD59-A6C34878D82A}">
                    <a16:rowId xmlns:a16="http://schemas.microsoft.com/office/drawing/2014/main" val="3614774702"/>
                  </a:ext>
                </a:extLst>
              </a:tr>
              <a:tr h="150688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900" u="none" strike="noStrike">
                          <a:effectLst/>
                        </a:rPr>
                        <a:t>17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373" marR="4373" marT="437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</a:rPr>
                        <a:t>Alameddine et al. (2019)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373" marR="4373" marT="437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900" u="none" strike="noStrike">
                          <a:effectLst/>
                        </a:rPr>
                        <a:t>80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373" marR="4373" marT="437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</a:rPr>
                        <a:t>Female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373" marR="4373" marT="437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</a:rPr>
                        <a:t>AS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373" marR="4373" marT="437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</a:rPr>
                        <a:t>BAV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373" marR="4373" marT="437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</a:rPr>
                        <a:t>AVR 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373" marR="4373" marT="437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</a:rPr>
                        <a:t>Selection of undersized PV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373" marR="4373" marT="437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 dirty="0">
                          <a:effectLst/>
                        </a:rPr>
                        <a:t>CI for occluded ALCX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373" marR="4373" marT="4373" marB="0" anchor="ctr"/>
                </a:tc>
                <a:extLst>
                  <a:ext uri="{0D108BD9-81ED-4DB2-BD59-A6C34878D82A}">
                    <a16:rowId xmlns:a16="http://schemas.microsoft.com/office/drawing/2014/main" val="2603939280"/>
                  </a:ext>
                </a:extLst>
              </a:tr>
              <a:tr h="150688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900" u="none" strike="noStrike">
                          <a:effectLst/>
                        </a:rPr>
                        <a:t>18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373" marR="4373" marT="437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</a:rPr>
                        <a:t>same as above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373" marR="4373" marT="437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900" u="none" strike="noStrike">
                          <a:effectLst/>
                        </a:rPr>
                        <a:t>86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373" marR="4373" marT="437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</a:rPr>
                        <a:t>Female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373" marR="4373" marT="437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</a:rPr>
                        <a:t>AS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373" marR="4373" marT="437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</a:rPr>
                        <a:t>BAV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373" marR="4373" marT="437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</a:rPr>
                        <a:t>AVR 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373" marR="4373" marT="437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</a:rPr>
                        <a:t>Selection of undersized PV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373" marR="4373" marT="437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 dirty="0">
                          <a:effectLst/>
                        </a:rPr>
                        <a:t>CI for occluded ALCX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373" marR="4373" marT="4373" marB="0" anchor="ctr"/>
                </a:tc>
                <a:extLst>
                  <a:ext uri="{0D108BD9-81ED-4DB2-BD59-A6C34878D82A}">
                    <a16:rowId xmlns:a16="http://schemas.microsoft.com/office/drawing/2014/main" val="1910171511"/>
                  </a:ext>
                </a:extLst>
              </a:tr>
              <a:tr h="150688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900" u="none" strike="noStrike">
                          <a:effectLst/>
                        </a:rPr>
                        <a:t>19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373" marR="4373" marT="437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</a:rPr>
                        <a:t>same as above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373" marR="4373" marT="437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900" u="none" strike="noStrike">
                          <a:effectLst/>
                        </a:rPr>
                        <a:t>33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373" marR="4373" marT="437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</a:rPr>
                        <a:t>Male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373" marR="4373" marT="437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</a:rPr>
                        <a:t>AR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373" marR="4373" marT="437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</a:rPr>
                        <a:t>TAV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373" marR="4373" marT="437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</a:rPr>
                        <a:t>AVR 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373" marR="4373" marT="437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</a:rPr>
                        <a:t>CABG 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373" marR="4373" marT="437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 dirty="0">
                          <a:effectLst/>
                        </a:rPr>
                        <a:t>Uneventful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373" marR="4373" marT="4373" marB="0" anchor="ctr"/>
                </a:tc>
                <a:extLst>
                  <a:ext uri="{0D108BD9-81ED-4DB2-BD59-A6C34878D82A}">
                    <a16:rowId xmlns:a16="http://schemas.microsoft.com/office/drawing/2014/main" val="1037366370"/>
                  </a:ext>
                </a:extLst>
              </a:tr>
              <a:tr h="296721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900" u="none" strike="noStrike">
                          <a:effectLst/>
                        </a:rPr>
                        <a:t>20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373" marR="4373" marT="437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</a:rPr>
                        <a:t>same as above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373" marR="4373" marT="437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900" u="none" strike="noStrike">
                          <a:effectLst/>
                        </a:rPr>
                        <a:t>81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373" marR="4373" marT="437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</a:rPr>
                        <a:t>Male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373" marR="4373" marT="437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</a:rPr>
                        <a:t>AS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373" marR="4373" marT="437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</a:rPr>
                        <a:t>TAV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373" marR="4373" marT="437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</a:rPr>
                        <a:t>AVR 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373" marR="4373" marT="437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</a:rPr>
                        <a:t>D&amp;R of the ALCX</a:t>
                      </a:r>
                      <a:br>
                        <a:rPr lang="en-US" sz="900" u="none" strike="noStrike">
                          <a:effectLst/>
                        </a:rPr>
                      </a:br>
                      <a:r>
                        <a:rPr lang="en-US" sz="900" u="none" strike="noStrike">
                          <a:effectLst/>
                        </a:rPr>
                        <a:t>CABG 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373" marR="4373" marT="437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 dirty="0">
                          <a:effectLst/>
                        </a:rPr>
                        <a:t>Uneventful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373" marR="4373" marT="4373" marB="0" anchor="ctr"/>
                </a:tc>
                <a:extLst>
                  <a:ext uri="{0D108BD9-81ED-4DB2-BD59-A6C34878D82A}">
                    <a16:rowId xmlns:a16="http://schemas.microsoft.com/office/drawing/2014/main" val="1626438721"/>
                  </a:ext>
                </a:extLst>
              </a:tr>
              <a:tr h="296721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900" u="none" strike="noStrike">
                          <a:effectLst/>
                        </a:rPr>
                        <a:t>21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373" marR="4373" marT="437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</a:rPr>
                        <a:t>same as above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373" marR="4373" marT="437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900" u="none" strike="noStrike">
                          <a:effectLst/>
                        </a:rPr>
                        <a:t>81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373" marR="4373" marT="437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</a:rPr>
                        <a:t>Male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373" marR="4373" marT="437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</a:rPr>
                        <a:t>AS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373" marR="4373" marT="437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</a:rPr>
                        <a:t>TAV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373" marR="4373" marT="437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</a:rPr>
                        <a:t>AVR 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373" marR="4373" marT="437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</a:rPr>
                        <a:t>Selection of undersized PV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373" marR="4373" marT="437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 dirty="0">
                          <a:effectLst/>
                        </a:rPr>
                        <a:t>Uneventful recovery </a:t>
                      </a:r>
                      <a:br>
                        <a:rPr lang="en-US" sz="900" u="none" strike="noStrike" dirty="0">
                          <a:effectLst/>
                        </a:rPr>
                      </a:br>
                      <a:r>
                        <a:rPr lang="en-US" sz="900" u="none" strike="noStrike" dirty="0">
                          <a:effectLst/>
                        </a:rPr>
                        <a:t> despite ALCX stenosis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373" marR="4373" marT="4373" marB="0" anchor="ctr"/>
                </a:tc>
                <a:extLst>
                  <a:ext uri="{0D108BD9-81ED-4DB2-BD59-A6C34878D82A}">
                    <a16:rowId xmlns:a16="http://schemas.microsoft.com/office/drawing/2014/main" val="3396332997"/>
                  </a:ext>
                </a:extLst>
              </a:tr>
              <a:tr h="150688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900" u="none" strike="noStrike">
                          <a:effectLst/>
                        </a:rPr>
                        <a:t>22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373" marR="4373" marT="437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</a:rPr>
                        <a:t>same as above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373" marR="4373" marT="437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900" u="none" strike="noStrike">
                          <a:effectLst/>
                        </a:rPr>
                        <a:t>79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373" marR="4373" marT="437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</a:rPr>
                        <a:t>Female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373" marR="4373" marT="437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</a:rPr>
                        <a:t>AS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373" marR="4373" marT="437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</a:rPr>
                        <a:t>TAV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373" marR="4373" marT="437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</a:rPr>
                        <a:t>TAVR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373" marR="4373" marT="437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</a:rPr>
                        <a:t>Selection of undersized PV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373" marR="4373" marT="437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 dirty="0">
                          <a:effectLst/>
                        </a:rPr>
                        <a:t>Uneventful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373" marR="4373" marT="4373" marB="0" anchor="ctr"/>
                </a:tc>
                <a:extLst>
                  <a:ext uri="{0D108BD9-81ED-4DB2-BD59-A6C34878D82A}">
                    <a16:rowId xmlns:a16="http://schemas.microsoft.com/office/drawing/2014/main" val="1741298307"/>
                  </a:ext>
                </a:extLst>
              </a:tr>
              <a:tr h="150688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900" u="none" strike="noStrike">
                          <a:effectLst/>
                        </a:rPr>
                        <a:t>23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373" marR="4373" marT="437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</a:rPr>
                        <a:t>same as above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373" marR="4373" marT="437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900" u="none" strike="noStrike">
                          <a:effectLst/>
                        </a:rPr>
                        <a:t>85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373" marR="4373" marT="437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</a:rPr>
                        <a:t>Male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373" marR="4373" marT="437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</a:rPr>
                        <a:t>AS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373" marR="4373" marT="437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</a:rPr>
                        <a:t>TAV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373" marR="4373" marT="437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</a:rPr>
                        <a:t>TAVR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373" marR="4373" marT="437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</a:rPr>
                        <a:t>Selection of undersized PV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373" marR="4373" marT="437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 dirty="0">
                          <a:effectLst/>
                        </a:rPr>
                        <a:t>Uneventful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373" marR="4373" marT="4373" marB="0" anchor="ctr"/>
                </a:tc>
                <a:extLst>
                  <a:ext uri="{0D108BD9-81ED-4DB2-BD59-A6C34878D82A}">
                    <a16:rowId xmlns:a16="http://schemas.microsoft.com/office/drawing/2014/main" val="3510398394"/>
                  </a:ext>
                </a:extLst>
              </a:tr>
              <a:tr h="296721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900" u="none" strike="noStrike">
                          <a:effectLst/>
                        </a:rPr>
                        <a:t>24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373" marR="4373" marT="437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</a:rPr>
                        <a:t>Fabozzo et al. (2019)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373" marR="4373" marT="437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900" u="none" strike="noStrike">
                          <a:effectLst/>
                        </a:rPr>
                        <a:t>48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373" marR="4373" marT="437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</a:rPr>
                        <a:t>Male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373" marR="4373" marT="437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</a:rPr>
                        <a:t>MR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373" marR="4373" marT="437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</a:rPr>
                        <a:t>Not available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373" marR="4373" marT="437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</a:rPr>
                        <a:t>MVP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373" marR="4373" marT="437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</a:rPr>
                        <a:t>Not in particular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373" marR="4373" marT="437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 dirty="0">
                          <a:effectLst/>
                        </a:rPr>
                        <a:t>Recovery after VA-ECMO</a:t>
                      </a:r>
                      <a:br>
                        <a:rPr lang="en-US" sz="900" u="none" strike="noStrike" dirty="0">
                          <a:effectLst/>
                        </a:rPr>
                      </a:br>
                      <a:r>
                        <a:rPr lang="en-US" sz="900" u="none" strike="noStrike" dirty="0">
                          <a:effectLst/>
                        </a:rPr>
                        <a:t> for occluded ALCX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373" marR="4373" marT="4373" marB="0" anchor="ctr"/>
                </a:tc>
                <a:extLst>
                  <a:ext uri="{0D108BD9-81ED-4DB2-BD59-A6C34878D82A}">
                    <a16:rowId xmlns:a16="http://schemas.microsoft.com/office/drawing/2014/main" val="2929685441"/>
                  </a:ext>
                </a:extLst>
              </a:tr>
              <a:tr h="150688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900" u="none" strike="noStrike">
                          <a:effectLst/>
                        </a:rPr>
                        <a:t>25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373" marR="4373" marT="437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</a:rPr>
                        <a:t>Ujihira et al. (2019)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373" marR="4373" marT="437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900" u="none" strike="noStrike">
                          <a:effectLst/>
                        </a:rPr>
                        <a:t>80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373" marR="4373" marT="437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</a:rPr>
                        <a:t>Male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373" marR="4373" marT="437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</a:rPr>
                        <a:t>AS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373" marR="4373" marT="437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</a:rPr>
                        <a:t>TAV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373" marR="4373" marT="437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</a:rPr>
                        <a:t>TAVR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373" marR="4373" marT="437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</a:rPr>
                        <a:t>Preparation for CI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373" marR="4373" marT="437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 dirty="0">
                          <a:effectLst/>
                        </a:rPr>
                        <a:t>Uneventful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373" marR="4373" marT="4373" marB="0" anchor="ctr"/>
                </a:tc>
                <a:extLst>
                  <a:ext uri="{0D108BD9-81ED-4DB2-BD59-A6C34878D82A}">
                    <a16:rowId xmlns:a16="http://schemas.microsoft.com/office/drawing/2014/main" val="3959756401"/>
                  </a:ext>
                </a:extLst>
              </a:tr>
              <a:tr h="150688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900" u="none" strike="noStrike">
                          <a:effectLst/>
                        </a:rPr>
                        <a:t>26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373" marR="4373" marT="437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</a:rPr>
                        <a:t>same as above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373" marR="4373" marT="437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900" u="none" strike="noStrike">
                          <a:effectLst/>
                        </a:rPr>
                        <a:t>87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373" marR="4373" marT="437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</a:rPr>
                        <a:t>Male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373" marR="4373" marT="437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</a:rPr>
                        <a:t>AS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373" marR="4373" marT="437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</a:rPr>
                        <a:t>TAV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373" marR="4373" marT="437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</a:rPr>
                        <a:t>TAVR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373" marR="4373" marT="437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</a:rPr>
                        <a:t>Not in particular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373" marR="4373" marT="437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 dirty="0">
                          <a:effectLst/>
                        </a:rPr>
                        <a:t>Uneventful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373" marR="4373" marT="4373" marB="0" anchor="ctr"/>
                </a:tc>
                <a:extLst>
                  <a:ext uri="{0D108BD9-81ED-4DB2-BD59-A6C34878D82A}">
                    <a16:rowId xmlns:a16="http://schemas.microsoft.com/office/drawing/2014/main" val="1086684414"/>
                  </a:ext>
                </a:extLst>
              </a:tr>
              <a:tr h="150688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900" u="none" strike="noStrike">
                          <a:effectLst/>
                        </a:rPr>
                        <a:t>27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373" marR="4373" marT="437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</a:rPr>
                        <a:t>same as above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373" marR="4373" marT="437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900" u="none" strike="noStrike">
                          <a:effectLst/>
                        </a:rPr>
                        <a:t>80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373" marR="4373" marT="437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</a:rPr>
                        <a:t>Male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373" marR="4373" marT="437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</a:rPr>
                        <a:t>AS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373" marR="4373" marT="437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</a:rPr>
                        <a:t>TAV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373" marR="4373" marT="437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</a:rPr>
                        <a:t>TAVR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373" marR="4373" marT="437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</a:rPr>
                        <a:t>Not in particular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373" marR="4373" marT="437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 dirty="0">
                          <a:effectLst/>
                        </a:rPr>
                        <a:t>Uneventful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373" marR="4373" marT="4373" marB="0" anchor="ctr"/>
                </a:tc>
                <a:extLst>
                  <a:ext uri="{0D108BD9-81ED-4DB2-BD59-A6C34878D82A}">
                    <a16:rowId xmlns:a16="http://schemas.microsoft.com/office/drawing/2014/main" val="674536511"/>
                  </a:ext>
                </a:extLst>
              </a:tr>
              <a:tr h="150688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900" u="none" strike="noStrike">
                          <a:effectLst/>
                        </a:rPr>
                        <a:t>28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373" marR="4373" marT="437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</a:rPr>
                        <a:t>Botta et al. (2020)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373" marR="4373" marT="437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900" u="none" strike="noStrike">
                          <a:effectLst/>
                        </a:rPr>
                        <a:t>31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373" marR="4373" marT="437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</a:rPr>
                        <a:t>Male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373" marR="4373" marT="437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</a:rPr>
                        <a:t>IE/AR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373" marR="4373" marT="437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</a:rPr>
                        <a:t>BAV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373" marR="4373" marT="437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</a:rPr>
                        <a:t>AVR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373" marR="4373" marT="437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</a:rPr>
                        <a:t>D&amp;R of the ALCX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373" marR="4373" marT="437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 dirty="0">
                          <a:effectLst/>
                        </a:rPr>
                        <a:t>Uneventful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373" marR="4373" marT="4373" marB="0" anchor="ctr"/>
                </a:tc>
                <a:extLst>
                  <a:ext uri="{0D108BD9-81ED-4DB2-BD59-A6C34878D82A}">
                    <a16:rowId xmlns:a16="http://schemas.microsoft.com/office/drawing/2014/main" val="3406409098"/>
                  </a:ext>
                </a:extLst>
              </a:tr>
              <a:tr h="150688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900" u="none" strike="noStrike">
                          <a:effectLst/>
                        </a:rPr>
                        <a:t>29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373" marR="4373" marT="437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</a:rPr>
                        <a:t>same as above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373" marR="4373" marT="437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900" u="none" strike="noStrike">
                          <a:effectLst/>
                        </a:rPr>
                        <a:t>67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373" marR="4373" marT="437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</a:rPr>
                        <a:t>Female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373" marR="4373" marT="437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</a:rPr>
                        <a:t>AS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373" marR="4373" marT="437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</a:rPr>
                        <a:t>Not available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373" marR="4373" marT="437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</a:rPr>
                        <a:t>AVR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373" marR="4373" marT="437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</a:rPr>
                        <a:t>D&amp;R of the ALCX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373" marR="4373" marT="437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 dirty="0">
                          <a:effectLst/>
                        </a:rPr>
                        <a:t>Uneventful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373" marR="4373" marT="4373" marB="0" anchor="ctr"/>
                </a:tc>
                <a:extLst>
                  <a:ext uri="{0D108BD9-81ED-4DB2-BD59-A6C34878D82A}">
                    <a16:rowId xmlns:a16="http://schemas.microsoft.com/office/drawing/2014/main" val="4118211708"/>
                  </a:ext>
                </a:extLst>
              </a:tr>
              <a:tr h="150688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900" u="none" strike="noStrike">
                          <a:effectLst/>
                        </a:rPr>
                        <a:t>30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373" marR="4373" marT="437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</a:rPr>
                        <a:t>same as above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373" marR="4373" marT="437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900" u="none" strike="noStrike">
                          <a:effectLst/>
                        </a:rPr>
                        <a:t>79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373" marR="4373" marT="437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</a:rPr>
                        <a:t>Female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373" marR="4373" marT="437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</a:rPr>
                        <a:t>AS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373" marR="4373" marT="437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</a:rPr>
                        <a:t>Not available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373" marR="4373" marT="437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</a:rPr>
                        <a:t>AVR 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373" marR="4373" marT="437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</a:rPr>
                        <a:t>D&amp;R of the ALCX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373" marR="4373" marT="437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 dirty="0">
                          <a:effectLst/>
                        </a:rPr>
                        <a:t>Uneventful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373" marR="4373" marT="4373" marB="0" anchor="ctr"/>
                </a:tc>
                <a:extLst>
                  <a:ext uri="{0D108BD9-81ED-4DB2-BD59-A6C34878D82A}">
                    <a16:rowId xmlns:a16="http://schemas.microsoft.com/office/drawing/2014/main" val="3615405530"/>
                  </a:ext>
                </a:extLst>
              </a:tr>
              <a:tr h="150688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900" u="none" strike="noStrike">
                          <a:effectLst/>
                        </a:rPr>
                        <a:t>31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373" marR="4373" marT="437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</a:rPr>
                        <a:t>Mbai et al.  (2020) 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373" marR="4373" marT="437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900" u="none" strike="noStrike">
                          <a:effectLst/>
                        </a:rPr>
                        <a:t>72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373" marR="4373" marT="437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</a:rPr>
                        <a:t>Male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373" marR="4373" marT="437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</a:rPr>
                        <a:t>AS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373" marR="4373" marT="437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</a:rPr>
                        <a:t>BAV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373" marR="4373" marT="437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</a:rPr>
                        <a:t>TAVR 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373" marR="4373" marT="437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</a:rPr>
                        <a:t>Preparation for CI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373" marR="4373" marT="437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 dirty="0">
                          <a:effectLst/>
                        </a:rPr>
                        <a:t>Uneventful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373" marR="4373" marT="4373" marB="0" anchor="ctr"/>
                </a:tc>
                <a:extLst>
                  <a:ext uri="{0D108BD9-81ED-4DB2-BD59-A6C34878D82A}">
                    <a16:rowId xmlns:a16="http://schemas.microsoft.com/office/drawing/2014/main" val="2841275858"/>
                  </a:ext>
                </a:extLst>
              </a:tr>
              <a:tr h="150688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900" u="none" strike="noStrike">
                          <a:effectLst/>
                        </a:rPr>
                        <a:t>32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373" marR="4373" marT="437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</a:rPr>
                        <a:t>Kang et al. (2020)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373" marR="4373" marT="437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900" u="none" strike="noStrike">
                          <a:effectLst/>
                        </a:rPr>
                        <a:t>65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373" marR="4373" marT="437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</a:rPr>
                        <a:t>Male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373" marR="4373" marT="437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</a:rPr>
                        <a:t>AS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373" marR="4373" marT="437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</a:rPr>
                        <a:t>BAV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373" marR="4373" marT="437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</a:rPr>
                        <a:t>TAVR 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373" marR="4373" marT="437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</a:rPr>
                        <a:t>Preparation for CI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373" marR="4373" marT="437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 dirty="0">
                          <a:effectLst/>
                        </a:rPr>
                        <a:t>Uneventful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373" marR="4373" marT="4373" marB="0" anchor="ctr"/>
                </a:tc>
                <a:extLst>
                  <a:ext uri="{0D108BD9-81ED-4DB2-BD59-A6C34878D82A}">
                    <a16:rowId xmlns:a16="http://schemas.microsoft.com/office/drawing/2014/main" val="2248891565"/>
                  </a:ext>
                </a:extLst>
              </a:tr>
              <a:tr h="150688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900" u="none" strike="noStrike">
                          <a:effectLst/>
                        </a:rPr>
                        <a:t>33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373" marR="4373" marT="437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</a:rPr>
                        <a:t>Fukunaga et al. (2021)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373" marR="4373" marT="437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900" u="none" strike="noStrike">
                          <a:effectLst/>
                        </a:rPr>
                        <a:t>64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373" marR="4373" marT="437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</a:rPr>
                        <a:t>Male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373" marR="4373" marT="437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</a:rPr>
                        <a:t>AR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373" marR="4373" marT="437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</a:rPr>
                        <a:t>TAV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373" marR="4373" marT="437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</a:rPr>
                        <a:t>Remodeling method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373" marR="4373" marT="437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</a:rPr>
                        <a:t>Not in particular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373" marR="4373" marT="437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 dirty="0">
                          <a:effectLst/>
                        </a:rPr>
                        <a:t>Uneventful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373" marR="4373" marT="4373" marB="0" anchor="ctr"/>
                </a:tc>
                <a:extLst>
                  <a:ext uri="{0D108BD9-81ED-4DB2-BD59-A6C34878D82A}">
                    <a16:rowId xmlns:a16="http://schemas.microsoft.com/office/drawing/2014/main" val="2792501142"/>
                  </a:ext>
                </a:extLst>
              </a:tr>
              <a:tr h="150688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900" u="none" strike="noStrike">
                          <a:effectLst/>
                        </a:rPr>
                        <a:t>34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373" marR="4373" marT="437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</a:rPr>
                        <a:t>Aldauig et al. (2021) 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373" marR="4373" marT="437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900" u="none" strike="noStrike">
                          <a:effectLst/>
                        </a:rPr>
                        <a:t>82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373" marR="4373" marT="437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</a:rPr>
                        <a:t>Female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373" marR="4373" marT="437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</a:rPr>
                        <a:t>AS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373" marR="4373" marT="437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</a:rPr>
                        <a:t>TAV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373" marR="4373" marT="437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</a:rPr>
                        <a:t>TAVR  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373" marR="4373" marT="437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</a:rPr>
                        <a:t>High-position valve implantation 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373" marR="4373" marT="437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 dirty="0">
                          <a:effectLst/>
                        </a:rPr>
                        <a:t>Uneventful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373" marR="4373" marT="4373" marB="0" anchor="ctr"/>
                </a:tc>
                <a:extLst>
                  <a:ext uri="{0D108BD9-81ED-4DB2-BD59-A6C34878D82A}">
                    <a16:rowId xmlns:a16="http://schemas.microsoft.com/office/drawing/2014/main" val="2692611305"/>
                  </a:ext>
                </a:extLst>
              </a:tr>
              <a:tr h="150688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900" u="none" strike="noStrike">
                          <a:effectLst/>
                        </a:rPr>
                        <a:t>35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373" marR="4373" marT="437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</a:rPr>
                        <a:t>Thilak et al. (2024)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373" marR="4373" marT="437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900" u="none" strike="noStrike">
                          <a:effectLst/>
                        </a:rPr>
                        <a:t>43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373" marR="4373" marT="437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</a:rPr>
                        <a:t>Male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373" marR="4373" marT="437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</a:rPr>
                        <a:t>ASR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373" marR="4373" marT="437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</a:rPr>
                        <a:t>BAV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373" marR="4373" marT="437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</a:rPr>
                        <a:t>Bentall method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373" marR="4373" marT="437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</a:rPr>
                        <a:t>D&amp;R of the ALCX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373" marR="4373" marT="437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 dirty="0">
                          <a:effectLst/>
                        </a:rPr>
                        <a:t>Uneventful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373" marR="4373" marT="4373" marB="0" anchor="ctr"/>
                </a:tc>
                <a:extLst>
                  <a:ext uri="{0D108BD9-81ED-4DB2-BD59-A6C34878D82A}">
                    <a16:rowId xmlns:a16="http://schemas.microsoft.com/office/drawing/2014/main" val="3870285741"/>
                  </a:ext>
                </a:extLst>
              </a:tr>
              <a:tr h="296721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900" u="none" strike="noStrike">
                          <a:effectLst/>
                        </a:rPr>
                        <a:t>36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373" marR="4373" marT="4373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</a:rPr>
                        <a:t>our case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373" marR="4373" marT="4373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900" u="none" strike="noStrike">
                          <a:effectLst/>
                        </a:rPr>
                        <a:t>36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373" marR="4373" marT="4373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</a:rPr>
                        <a:t>Male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373" marR="4373" marT="4373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</a:rPr>
                        <a:t>AR, MV anuerysm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373" marR="4373" marT="4373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</a:rPr>
                        <a:t>BAV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373" marR="4373" marT="4373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 dirty="0">
                          <a:effectLst/>
                        </a:rPr>
                        <a:t>AVR </a:t>
                      </a:r>
                      <a:r>
                        <a:rPr lang="en-US" sz="900" u="none" strike="noStrike">
                          <a:effectLst/>
                        </a:rPr>
                        <a:t>and MVP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373" marR="4373" marT="4373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</a:rPr>
                        <a:t>Selection of undersized PV</a:t>
                      </a:r>
                      <a:br>
                        <a:rPr lang="en-US" sz="900" u="none" strike="noStrike">
                          <a:effectLst/>
                        </a:rPr>
                      </a:br>
                      <a:r>
                        <a:rPr lang="en-US" sz="900" u="none" strike="noStrike">
                          <a:effectLst/>
                        </a:rPr>
                        <a:t>CABG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373" marR="4373" marT="4373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 dirty="0">
                          <a:effectLst/>
                        </a:rPr>
                        <a:t>Uneventful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373" marR="4373" marT="4373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029391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39312678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2</TotalTime>
  <Words>686</Words>
  <Application>Microsoft Office PowerPoint</Application>
  <PresentationFormat>ワイド画面</PresentationFormat>
  <Paragraphs>334</Paragraphs>
  <Slides>1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5" baseType="lpstr">
      <vt:lpstr>游ゴシック</vt:lpstr>
      <vt:lpstr>游ゴシック Light</vt:lpstr>
      <vt:lpstr>Arial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貢之 古川</dc:creator>
  <cp:lastModifiedBy>貢之 古川</cp:lastModifiedBy>
  <cp:revision>6</cp:revision>
  <dcterms:created xsi:type="dcterms:W3CDTF">2025-04-14T11:14:14Z</dcterms:created>
  <dcterms:modified xsi:type="dcterms:W3CDTF">2025-04-20T05:28:15Z</dcterms:modified>
</cp:coreProperties>
</file>